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481" autoAdjust="0"/>
    <p:restoredTop sz="94660"/>
  </p:normalViewPr>
  <p:slideViewPr>
    <p:cSldViewPr snapToGrid="0">
      <p:cViewPr varScale="1">
        <p:scale>
          <a:sx n="97" d="100"/>
          <a:sy n="97" d="100"/>
        </p:scale>
        <p:origin x="1632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7073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1186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7" y="365127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2" y="365127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8985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3555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90" y="1709741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90" y="4589466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422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2873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3" y="365128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3" y="1681164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3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1739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0262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368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3" y="987428"/>
            <a:ext cx="4629151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2639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3" y="987428"/>
            <a:ext cx="4629151" cy="487362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1457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84B56-8B53-4EDC-802A-5115414725D8}" type="datetimeFigureOut">
              <a:rPr kumimoji="1" lang="ja-JP" altLang="en-US" smtClean="0"/>
              <a:pPr/>
              <a:t>2017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E1C0C-BD1C-41BD-A29B-C320BDBE803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959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角丸四角形 91"/>
          <p:cNvSpPr/>
          <p:nvPr/>
        </p:nvSpPr>
        <p:spPr>
          <a:xfrm>
            <a:off x="5306140" y="5596855"/>
            <a:ext cx="83889" cy="252000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角丸四角形 90"/>
          <p:cNvSpPr/>
          <p:nvPr/>
        </p:nvSpPr>
        <p:spPr>
          <a:xfrm>
            <a:off x="5303727" y="5217952"/>
            <a:ext cx="83889" cy="252000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角丸四角形 89"/>
          <p:cNvSpPr/>
          <p:nvPr/>
        </p:nvSpPr>
        <p:spPr>
          <a:xfrm>
            <a:off x="5302329" y="4696436"/>
            <a:ext cx="83889" cy="396000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角丸四角形 88"/>
          <p:cNvSpPr/>
          <p:nvPr/>
        </p:nvSpPr>
        <p:spPr>
          <a:xfrm>
            <a:off x="6064329" y="4183310"/>
            <a:ext cx="83889" cy="396000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角丸四角形 87"/>
          <p:cNvSpPr/>
          <p:nvPr/>
        </p:nvSpPr>
        <p:spPr>
          <a:xfrm>
            <a:off x="4779416" y="4188416"/>
            <a:ext cx="83889" cy="396000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角丸四角形 86"/>
          <p:cNvSpPr/>
          <p:nvPr/>
        </p:nvSpPr>
        <p:spPr>
          <a:xfrm>
            <a:off x="5296250" y="3677174"/>
            <a:ext cx="83889" cy="396000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角丸四角形 85"/>
          <p:cNvSpPr/>
          <p:nvPr/>
        </p:nvSpPr>
        <p:spPr>
          <a:xfrm>
            <a:off x="5304639" y="3048000"/>
            <a:ext cx="83889" cy="504000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角丸四角形 84"/>
          <p:cNvSpPr/>
          <p:nvPr/>
        </p:nvSpPr>
        <p:spPr>
          <a:xfrm>
            <a:off x="5296250" y="2301380"/>
            <a:ext cx="83889" cy="612000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角丸四角形 83"/>
          <p:cNvSpPr/>
          <p:nvPr/>
        </p:nvSpPr>
        <p:spPr>
          <a:xfrm>
            <a:off x="5306141" y="1645640"/>
            <a:ext cx="83889" cy="504000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角丸四角形 82"/>
          <p:cNvSpPr/>
          <p:nvPr/>
        </p:nvSpPr>
        <p:spPr>
          <a:xfrm>
            <a:off x="5293454" y="1015068"/>
            <a:ext cx="83889" cy="504000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834095" y="987905"/>
            <a:ext cx="768159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kumimoji="1" lang="en-US" altLang="ja-JP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n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-</a:t>
            </a:r>
            <a:r>
              <a:rPr kumimoji="1" lang="en-US" altLang="ja-JP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n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M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834095" y="1612581"/>
            <a:ext cx="808235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tp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-</a:t>
            </a:r>
            <a:r>
              <a: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ps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834095" y="2248869"/>
            <a:ext cx="737702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kumimoji="1" lang="en-US" altLang="ja-JP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tp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-</a:t>
            </a:r>
            <a:r>
              <a:rPr kumimoji="1" lang="en-US" altLang="ja-JP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bc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834095" y="3006732"/>
            <a:ext cx="772969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kumimoji="1" lang="en-US" altLang="ja-JP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n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tron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834095" y="3629781"/>
            <a:ext cx="822661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l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6 intron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834095" y="5160719"/>
            <a:ext cx="795411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s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6-</a:t>
            </a:r>
            <a:r>
              <a: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rn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834095" y="5551122"/>
            <a:ext cx="433132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s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正方形/長方形 46"/>
          <p:cNvSpPr/>
          <p:nvPr/>
        </p:nvSpPr>
        <p:spPr>
          <a:xfrm>
            <a:off x="3313272" y="978124"/>
            <a:ext cx="4147792" cy="50937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>
              <a:lnSpc>
                <a:spcPts val="1000"/>
              </a:lnSpc>
            </a:pPr>
            <a:r>
              <a:rPr lang="en-US" altLang="ja-JP" sz="1000" u="none" strike="noStrike" dirty="0" smtClean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3459:GCCTGCTGAATAAAAAAAAAGGGTTGGATATAGCCCTCTA:13498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u="none" strike="noStrike" dirty="0" smtClean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 413:GCCTGCTGAATAAAAAAAA-GGGTTGGATATAGCCCTCTA:  451</a:t>
            </a:r>
            <a:endParaRPr lang="en-US" altLang="ja-JP" sz="100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u="none" strike="noStrike" dirty="0" smtClean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 413:GCCTGCTGAATAAAAAAAAAGGGTTGGATATAGCCCTCTA:  452</a:t>
            </a:r>
            <a:endParaRPr lang="en-US" altLang="ja-JP" sz="100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u="none" strike="noStrike" dirty="0" smtClean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 413:GCCTGCTGAATAAAAAAAAAGGGTTGGATATAGCCCTCTA:  452</a:t>
            </a: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8889:TATTCTTTCTTTTATTATTATTATTATTATTATTTCTCGG:38928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232:TATTCTTTCTTTTATTATTATTATTATTATTATTTCTCGG:  271</a:t>
            </a:r>
            <a:endParaRPr lang="en-US" altLang="ja-JP" sz="100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232:TATTCTTTCTTTTATTATTCTTATTATTATTATTTCTCGG:  271</a:t>
            </a:r>
            <a:endParaRPr lang="en-US" altLang="ja-JP" sz="100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232:TATTCTTTCTTTTATTATTCTTATTATTATTATTTCTCGG:  271</a:t>
            </a:r>
            <a:endParaRPr lang="en-US" altLang="ja-JP" sz="100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7451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TATCTTTTTTTTTTTT-AGATTTTTGCAAAGGTTTC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:57489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637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TATCTTTTTTTTTTTT-AGATTTTTGCAAAGGTTTC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:  675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666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TATCTTTTTTTTTTTTTAGATTTTTGCAAAGGTTTC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:  705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666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TATCTTTTTTTTTTTT-AGATTTTTGCAAAGGTTTC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:  705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666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TATCTTTTTTTTTTTTTAGATTTTTGCAAAGGTTTC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:  705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3752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AAAAAAAAAAAAAAA-GAAATTGATTTTATTACGA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: 3790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442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AAAAAAAAAAAAAAAAGAAATTGATTTTATTACGA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:  481</a:t>
            </a: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442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AAAAAAAAAAAAAAA-GAAATTGATTTTATTACGA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:  480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442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AAAAAAAAAAAAAAA-GAAATTGATTTTATTACGA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:  480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1155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TTTCAATAAAATCCTATGTAGTCATAGGTTTTGTCG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:81194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25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TTTCAATAAAATCCTATGTAGTCATAGGTTTTGTCG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:   64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24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TTTCAATAAAATCCTAAGTAGTCATAGGTTTTGTCG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:   63</a:t>
            </a:r>
          </a:p>
          <a:p>
            <a:pPr>
              <a:lnSpc>
                <a:spcPts val="1000"/>
              </a:lnSpc>
            </a:pPr>
            <a:endParaRPr lang="en-US" altLang="ja-JP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1244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CAAAAAATTTCTTTCCGAGTCAATTTTCTCAGTTTTA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:81283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114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CAAAAAATTTTTTTCCGAGTCAATTTTTTCAGTTTTA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:  153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113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CAAAAAATTTCTTTCCGAGTCAATTTTTTCAGTTTTA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:  152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endParaRPr lang="en-US" altLang="ja-JP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1357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CTCTTTTTTTTTTTTT-AGAATTTTATTATATTGAT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:81395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227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CTCTTTTTTTTTTTTTTAGAATTTTATTATATTGAT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:  266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226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TCTCTTTTTTTTTTTTTTAGAATTTTATTATATTGAT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:  265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6083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ATTTTTTTTGTAAAGTAAAATTAAGGTCTTTGCTTT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: 6122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175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ATTTTTTTTGTAAAGTCAAATTAAGGTCTTTGCTTT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:  214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2260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CTCTGGTTTACAGAATTCACTTCCTTTTGGAGATCTT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:82299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182:</a:t>
            </a:r>
            <a:r>
              <a:rPr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CTCTGGTTTACAGAATTAACTTCCTTTTGGAGATCTT</a:t>
            </a:r>
            <a:r>
              <a:rPr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:  221</a:t>
            </a:r>
            <a:endParaRPr lang="ja-JP" alt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1" name="正方形/長方形 60"/>
          <p:cNvSpPr/>
          <p:nvPr/>
        </p:nvSpPr>
        <p:spPr>
          <a:xfrm>
            <a:off x="1596640" y="978124"/>
            <a:ext cx="1392575" cy="49468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180000" fontAlgn="ctr">
              <a:lnSpc>
                <a:spcPts val="1000"/>
              </a:lnSpc>
            </a:pPr>
            <a:r>
              <a:rPr lang="en-US" altLang="ja-JP" sz="1000" u="none" strike="noStrike" dirty="0" smtClean="0">
                <a:effectLst/>
                <a:latin typeface="Courier New" pitchFamily="49" charset="0"/>
                <a:cs typeface="Courier New" pitchFamily="49" charset="0"/>
              </a:rPr>
              <a:t>JW630</a:t>
            </a: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	</a:t>
            </a:r>
            <a:endParaRPr lang="en-US" altLang="ja-JP" sz="1000" u="none" strike="noStrike" dirty="0" smtClean="0">
              <a:effectLst/>
              <a:latin typeface="Courier New" pitchFamily="49" charset="0"/>
              <a:cs typeface="Courier New" pitchFamily="49" charset="0"/>
            </a:endParaRPr>
          </a:p>
          <a:p>
            <a:pPr defTabSz="180000" fontAlgn="ctr">
              <a:lnSpc>
                <a:spcPts val="1000"/>
              </a:lnSpc>
            </a:pPr>
            <a:r>
              <a:rPr lang="en-US" altLang="ja-JP" sz="1000" u="none" strike="noStrike" dirty="0" smtClean="0">
                <a:effectLst/>
                <a:latin typeface="Courier New" pitchFamily="49" charset="0"/>
                <a:cs typeface="Courier New" pitchFamily="49" charset="0"/>
              </a:rPr>
              <a:t>JW4 		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S76-174</a:t>
            </a:r>
            <a:r>
              <a:rPr lang="ja-JP" altLang="en-US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　</a:t>
            </a: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J76-349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JW630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JW4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S76-174</a:t>
            </a:r>
            <a:r>
              <a:rPr lang="ja-JP" altLang="en-US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　</a:t>
            </a: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J76-349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JW630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AT&amp;SS 864/THNHM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JW4    	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S76-174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J76-349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JW6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JW4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S76-174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J76-349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JW6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K76-88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ND03-1208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JW6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K76-88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ND03-1208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JW6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K76-88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ND03-1208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JW6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K76-88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JW6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IK76-88</a:t>
            </a:r>
          </a:p>
        </p:txBody>
      </p:sp>
      <p:sp>
        <p:nvSpPr>
          <p:cNvPr id="62" name="正方形/長方形 61"/>
          <p:cNvSpPr/>
          <p:nvPr/>
        </p:nvSpPr>
        <p:spPr>
          <a:xfrm>
            <a:off x="7425608" y="978124"/>
            <a:ext cx="857682" cy="49193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>
              <a:lnSpc>
                <a:spcPts val="1000"/>
              </a:lnSpc>
            </a:pPr>
            <a:r>
              <a:rPr lang="en-US" altLang="ja-JP" sz="1000" u="none" strike="noStrike" dirty="0" smtClean="0">
                <a:effectLst/>
                <a:latin typeface="Courier New" pitchFamily="49" charset="0"/>
                <a:cs typeface="Courier New" pitchFamily="49" charset="0"/>
              </a:rPr>
              <a:t>LC1601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u="none" strike="noStrike" dirty="0" smtClean="0">
                <a:effectLst/>
                <a:latin typeface="Courier New" pitchFamily="49" charset="0"/>
                <a:cs typeface="Courier New" pitchFamily="49" charset="0"/>
              </a:rPr>
              <a:t>AB731957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AB731958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AB731959</a:t>
            </a: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LC1601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AB731968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AB731969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AB731970</a:t>
            </a: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LC1601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GQ670125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AB731979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AB73198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AB731981</a:t>
            </a: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LC1601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AB732012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AB732013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AB732014</a:t>
            </a: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LC1601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KP764782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KP764783</a:t>
            </a: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LC1601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KP764782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KP764783</a:t>
            </a: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LC1601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KP764782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KP764783</a:t>
            </a: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LC1601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KP994101</a:t>
            </a:r>
          </a:p>
          <a:p>
            <a:pPr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LC160130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KP994095</a:t>
            </a:r>
          </a:p>
        </p:txBody>
      </p:sp>
      <p:sp>
        <p:nvSpPr>
          <p:cNvPr id="79" name="正方形/長方形 78"/>
          <p:cNvSpPr/>
          <p:nvPr/>
        </p:nvSpPr>
        <p:spPr>
          <a:xfrm>
            <a:off x="2810311" y="978124"/>
            <a:ext cx="604008" cy="50937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  <a:endParaRPr lang="en-US" altLang="ja-JP" sz="1000" u="none" strike="noStrike" dirty="0" smtClean="0">
              <a:effectLst/>
              <a:latin typeface="Courier New" pitchFamily="49" charset="0"/>
              <a:cs typeface="Courier New" pitchFamily="49" charset="0"/>
            </a:endParaRPr>
          </a:p>
          <a:p>
            <a:pPr defTabSz="180000" fontAlgn="ctr">
              <a:lnSpc>
                <a:spcPts val="1000"/>
              </a:lnSpc>
            </a:pPr>
            <a:r>
              <a:rPr lang="en-US" altLang="ja-JP" sz="1000" u="none" strike="noStrike" dirty="0" smtClean="0">
                <a:effectLst/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DN)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DN)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DN)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DN)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THA)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DN)</a:t>
            </a:r>
          </a:p>
          <a:p>
            <a:pPr defTabSz="180000"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DN)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DN)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DN)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ND)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ND)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ND)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ND)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ND)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ND)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ND)</a:t>
            </a:r>
          </a:p>
          <a:p>
            <a:pPr defTabSz="180000" fontAlgn="ctr">
              <a:lnSpc>
                <a:spcPts val="1000"/>
              </a:lnSpc>
            </a:pPr>
            <a:endParaRPr lang="en-US" altLang="ja-JP" sz="1000" dirty="0" smtClean="0">
              <a:solidFill>
                <a:srgbClr val="000000"/>
              </a:solidFill>
              <a:latin typeface="Courier New" pitchFamily="49" charset="0"/>
              <a:cs typeface="Courier New" pitchFamily="49" charset="0"/>
            </a:endParaRP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latin typeface="Courier New" pitchFamily="49" charset="0"/>
                <a:cs typeface="Courier New" pitchFamily="49" charset="0"/>
              </a:rPr>
              <a:t>(JPN)</a:t>
            </a:r>
          </a:p>
          <a:p>
            <a:pPr fontAlgn="ctr">
              <a:lnSpc>
                <a:spcPts val="1000"/>
              </a:lnSpc>
            </a:pPr>
            <a:r>
              <a:rPr lang="en-US" altLang="ja-JP" sz="1000" dirty="0" smtClean="0">
                <a:solidFill>
                  <a:srgbClr val="000000"/>
                </a:solidFill>
                <a:latin typeface="Courier New" pitchFamily="49" charset="0"/>
                <a:cs typeface="Courier New" pitchFamily="49" charset="0"/>
              </a:rPr>
              <a:t>(IND)</a:t>
            </a: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834095" y="4142908"/>
            <a:ext cx="822661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l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6 intron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834095" y="4651448"/>
            <a:ext cx="822661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l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6 intron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834095" y="663952"/>
            <a:ext cx="665567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ocation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1596640" y="663952"/>
            <a:ext cx="1120820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cession nam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2810311" y="663952"/>
            <a:ext cx="526106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rigin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3313272" y="663952"/>
            <a:ext cx="821059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7425608" y="591443"/>
            <a:ext cx="986167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nbank</a:t>
            </a:r>
            <a:endParaRPr kumimoji="1" lang="en-US" altLang="ja-JP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cession No.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386519" y="6261533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1 Fig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8889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0</TotalTime>
  <Words>301</Words>
  <Application>Microsoft Office PowerPoint</Application>
  <PresentationFormat>画面に合わせる (4:3)</PresentationFormat>
  <Paragraphs>16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Courier New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Tsuru</dc:creator>
  <cp:lastModifiedBy>STsuru</cp:lastModifiedBy>
  <cp:revision>30</cp:revision>
  <dcterms:created xsi:type="dcterms:W3CDTF">2016-10-31T08:06:51Z</dcterms:created>
  <dcterms:modified xsi:type="dcterms:W3CDTF">2017-01-06T03:54:28Z</dcterms:modified>
</cp:coreProperties>
</file>